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sayuki nagasawa" userId="7b636c6a3c404e39" providerId="LiveId" clId="{D975D539-CEDE-4847-9D69-C8C652DDBA43}"/>
    <pc:docChg chg="modSld">
      <pc:chgData name="masayuki nagasawa" userId="7b636c6a3c404e39" providerId="LiveId" clId="{D975D539-CEDE-4847-9D69-C8C652DDBA43}" dt="2024-05-07T07:15:23.148" v="50" actId="20577"/>
      <pc:docMkLst>
        <pc:docMk/>
      </pc:docMkLst>
      <pc:sldChg chg="modSp mod">
        <pc:chgData name="masayuki nagasawa" userId="7b636c6a3c404e39" providerId="LiveId" clId="{D975D539-CEDE-4847-9D69-C8C652DDBA43}" dt="2024-05-07T07:15:23.148" v="50" actId="20577"/>
        <pc:sldMkLst>
          <pc:docMk/>
          <pc:sldMk cId="1595227255" sldId="256"/>
        </pc:sldMkLst>
        <pc:spChg chg="mod">
          <ac:chgData name="masayuki nagasawa" userId="7b636c6a3c404e39" providerId="LiveId" clId="{D975D539-CEDE-4847-9D69-C8C652DDBA43}" dt="2024-05-07T07:15:23.148" v="50" actId="20577"/>
          <ac:spMkLst>
            <pc:docMk/>
            <pc:sldMk cId="1595227255" sldId="256"/>
            <ac:spMk id="8" creationId="{D9AA4928-E06A-990A-A4D2-50A36FFCA74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159319-332B-4988-B396-E5F5D281802C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14CD83-7129-49DF-A5FF-94B38041AD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1844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14CD83-7129-49DF-A5FF-94B38041AD3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144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E1201A-2859-4CAA-735C-675FB60BD8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0A09857-636C-565B-CB9E-40027564D0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73B3FC-C6CA-D0D4-8E97-337491F8B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D0F8E4-08B6-FEAF-A081-4BF2E413E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A724EA-3416-9F83-9291-3F19DD7D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3725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5A507D-C4B4-3786-A68A-32663E807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542E625-8B7A-DE82-113A-EC531AF99B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0E5371-641E-5348-4447-6AA80CFA1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EC2F51-56CF-43DD-4618-069576A3B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0C4DC6-0612-6592-F49A-2F47396CC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32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29E47F8-E032-1BF7-0080-DB76F943B5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2C3D029-28FC-EE65-D28B-36E32DADDA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73B089-D99B-707C-A204-04293115B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D98F70-68ED-F0C6-D1DF-58253AF10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B040D1-065D-A62B-2913-02D022D21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602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810241-AE43-EE18-CB5B-B4800014C5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D36044-826D-E479-D0BE-05910DCAC9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37BFF9C-6047-D138-22E3-A32FE7CE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0368F6-88DD-BE7E-0AEA-A17ADA913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1C4665-EDA7-C87E-4E7C-D22E44615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5459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9CBD36-27A2-0409-8566-B8A0C47A5D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2C00786-D77E-3793-DAA9-83BA878AD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D21B82-7890-BFBA-A236-A235C02DC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3A744C-ED43-36AE-FE83-F85F55C8C0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FE33E3-E670-0BC2-953B-96FFCC504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531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594BFF-96F9-8010-E150-5BF4E80A7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9D74BD-144F-E4D6-C9DF-5C312FE267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FFCE426-B45E-CE83-B6D5-EDF6BC7EA5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878D2D-951F-5BE3-67A6-461EE2FE0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EE57FE0-5779-524F-6537-9183E1AA9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2255D14-0CAF-EFBF-EBDD-3EF2219BD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2623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114D59-E897-4154-95BA-C24B48D430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6F5461-4C04-0B12-4E9C-D005A39A45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ED04CAD-1990-960A-0AAC-6AB0421868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292F94B-71DF-B361-EA4E-0755E9C024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ED1AB0F-3302-6D7C-B6A4-AD4753BCCA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F81507E-FB05-D6F7-1FE6-6E1E50FB6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E2C8DE0-5E3E-3771-5522-E1B2D4F16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918A5A-8F06-478C-725B-86EC2480F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016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E04A8C-BAA2-D072-F725-536B4A2264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1423A23-557F-3617-05C7-4A4EA8CA8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85633E8-8586-4429-4E4A-E10BD6426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B3A6E1C-777F-3A2D-1989-726F5985B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6861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17ABD5E-A5C3-E4B2-BE05-0C50C2982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3F9DFC8-D2FB-2D91-56A5-A5DD4354E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46F3678-1BAA-DE3C-4B0E-83DE42E83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18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260BD6-8A6D-13F7-E589-32DDC47A2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FCF2C5-F976-9C1B-6156-AE1F043726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962BD3F-7E88-A300-7543-A80A97C2EC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8FED31-609B-97CC-1350-0D35A21BC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26A02F-C4D7-3872-12B4-D71BF37A8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DBC61B-7F25-EF73-910F-D34D9256A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76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4FD917-22E5-3435-1707-C4F712E133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0F213FB-6BFA-B5C2-6DF3-5D07232BC7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EA1BDAB-EFB7-7E7B-21D9-94160DCE03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94E9728-68B1-62B8-9EEE-EA76ECB9E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22C2C6A-9B4B-2D26-AA11-9556EF056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A9A360E-38BF-E354-3A21-9E306458E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770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7BEEFBF-6927-4EAB-2670-322C1A10AE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3B0ABB-7777-54DF-18C3-B91E91C809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54B89B-01AB-77FE-3706-C81B2C94CE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8EAFD-F399-4263-8B8F-4FCE7E8D6ACA}" type="datetimeFigureOut">
              <a:rPr kumimoji="1" lang="ja-JP" altLang="en-US" smtClean="0"/>
              <a:t>2024/5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4349ED-01B0-C896-FD62-984BB4A3E8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23247A-F775-A631-1474-49D52B97D6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74A4A-78E5-46A2-9AFC-AB6898AE9D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638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9AA4928-E06A-990A-A4D2-50A36FFCA740}"/>
              </a:ext>
            </a:extLst>
          </p:cNvPr>
          <p:cNvSpPr txBox="1"/>
          <p:nvPr/>
        </p:nvSpPr>
        <p:spPr>
          <a:xfrm>
            <a:off x="2836334" y="5277138"/>
            <a:ext cx="7171267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Palatino Linotype" panose="02040502050505030304" pitchFamily="18" charset="0"/>
              </a:rPr>
              <a:t>Between January 2012 and December 2020, 599 patients aged &lt; 10 years were admitted urgently to our hospital because of status epilepticus or cluster spasms associated with fever (≧38 ℃). 87 patients diagnosed with epilepsy and those taking antiepileptic medication were excluded, and 512 patients were analyzed. Point-of-care antigen test for influenza virus (Flu), respiratory syncytial virus (RSV), adenovirus (</a:t>
            </a:r>
            <a:r>
              <a:rPr lang="en-US" altLang="ja-JP" sz="1100" dirty="0" err="1">
                <a:latin typeface="Palatino Linotype" panose="02040502050505030304" pitchFamily="18" charset="0"/>
              </a:rPr>
              <a:t>AdV</a:t>
            </a:r>
            <a:r>
              <a:rPr lang="en-US" altLang="ja-JP" sz="1100" dirty="0">
                <a:latin typeface="Palatino Linotype" panose="02040502050505030304" pitchFamily="18" charset="0"/>
              </a:rPr>
              <a:t>), and human metapneumovirus (hMPV) was performed at the discretion of physicians.   FC: febrile convulsions</a:t>
            </a:r>
            <a:endParaRPr lang="ja-JP" altLang="en-U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1141CB87-43A1-784D-E7BA-B5CB57F3EB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90935"/>
              </p:ext>
            </p:extLst>
          </p:nvPr>
        </p:nvGraphicFramePr>
        <p:xfrm>
          <a:off x="3961062" y="828684"/>
          <a:ext cx="4117475" cy="4403616"/>
        </p:xfrm>
        <a:graphic>
          <a:graphicData uri="http://schemas.openxmlformats.org/drawingml/2006/table">
            <a:tbl>
              <a:tblPr/>
              <a:tblGrid>
                <a:gridCol w="1915683">
                  <a:extLst>
                    <a:ext uri="{9D8B030D-6E8A-4147-A177-3AD203B41FA5}">
                      <a16:colId xmlns:a16="http://schemas.microsoft.com/office/drawing/2014/main" val="2643968422"/>
                    </a:ext>
                  </a:extLst>
                </a:gridCol>
                <a:gridCol w="584657">
                  <a:extLst>
                    <a:ext uri="{9D8B030D-6E8A-4147-A177-3AD203B41FA5}">
                      <a16:colId xmlns:a16="http://schemas.microsoft.com/office/drawing/2014/main" val="3447488023"/>
                    </a:ext>
                  </a:extLst>
                </a:gridCol>
                <a:gridCol w="522459">
                  <a:extLst>
                    <a:ext uri="{9D8B030D-6E8A-4147-A177-3AD203B41FA5}">
                      <a16:colId xmlns:a16="http://schemas.microsoft.com/office/drawing/2014/main" val="3037960354"/>
                    </a:ext>
                  </a:extLst>
                </a:gridCol>
                <a:gridCol w="1094676">
                  <a:extLst>
                    <a:ext uri="{9D8B030D-6E8A-4147-A177-3AD203B41FA5}">
                      <a16:colId xmlns:a16="http://schemas.microsoft.com/office/drawing/2014/main" val="1381244610"/>
                    </a:ext>
                  </a:extLst>
                </a:gridCol>
              </a:tblGrid>
              <a:tr h="17912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043599"/>
                  </a:ext>
                </a:extLst>
              </a:tr>
              <a:tr h="179129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positive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positive ratio (%)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3390408"/>
                  </a:ext>
                </a:extLst>
              </a:tr>
              <a:tr h="179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C patients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512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2142063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t least one Ag tested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343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98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8.6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518730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73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62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2.7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4031429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S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24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0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6.1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41718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d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89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7.9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1559779"/>
                  </a:ext>
                </a:extLst>
              </a:tr>
              <a:tr h="179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36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9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5.0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4467421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4681684"/>
                  </a:ext>
                </a:extLst>
              </a:tr>
              <a:tr h="179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test combination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atio(%)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1367904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58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46.1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8484543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+ RS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54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5.7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2031488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+ Ad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31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9.0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8867990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+ 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0.3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2130286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+ RSV + Ad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4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4.1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9830461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+ RSV + 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9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.6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9030741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Flu + RSV + AdV + 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6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.7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5231360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S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5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4.4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9031791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SV + Ad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8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.3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215246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SV + 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6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4.7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2381754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SV + AdV + 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0.6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135135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d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27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7.9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4246261"/>
                  </a:ext>
                </a:extLst>
              </a:tr>
              <a:tr h="1735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dV + 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0.3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6586311"/>
                  </a:ext>
                </a:extLst>
              </a:tr>
              <a:tr h="1809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hMPV Ag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1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0.3%</a:t>
                      </a: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5332273"/>
                  </a:ext>
                </a:extLst>
              </a:tr>
              <a:tr h="171665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7464" marR="7464" marT="746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5453482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6DCAD23-06FC-1569-D2B1-F94B41DC3690}"/>
              </a:ext>
            </a:extLst>
          </p:cNvPr>
          <p:cNvSpPr txBox="1"/>
          <p:nvPr/>
        </p:nvSpPr>
        <p:spPr>
          <a:xfrm>
            <a:off x="224117" y="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1595227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9</Words>
  <Application>Microsoft Office PowerPoint</Application>
  <PresentationFormat>ワイド画面</PresentationFormat>
  <Paragraphs>8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yuki nagasawa</dc:creator>
  <cp:lastModifiedBy>masayuki nagasawa</cp:lastModifiedBy>
  <cp:revision>1</cp:revision>
  <dcterms:created xsi:type="dcterms:W3CDTF">2024-02-14T07:53:49Z</dcterms:created>
  <dcterms:modified xsi:type="dcterms:W3CDTF">2024-05-07T07:15:29Z</dcterms:modified>
</cp:coreProperties>
</file>